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 showGuides="1">
      <p:cViewPr>
        <p:scale>
          <a:sx n="125" d="100"/>
          <a:sy n="125" d="100"/>
        </p:scale>
        <p:origin x="-1236" y="-150"/>
      </p:cViewPr>
      <p:guideLst>
        <p:guide orient="horz" pos="2040"/>
        <p:guide orient="horz" pos="1789"/>
        <p:guide pos="2880"/>
        <p:guide pos="1066"/>
        <p:guide pos="1817"/>
        <p:guide pos="3486"/>
        <p:guide pos="42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7715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7513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8312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5748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640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7749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6763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0243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110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5844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6009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8DF7E9-409F-4ED8-BBC2-077DCAA66358}" type="datetimeFigureOut">
              <a:rPr lang="fr-FR" smtClean="0"/>
              <a:t>23/06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9F1208-0C94-4263-945D-7B8D66F4F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4472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e 6"/>
          <p:cNvGrpSpPr>
            <a:grpSpLocks noChangeAspect="1"/>
          </p:cNvGrpSpPr>
          <p:nvPr/>
        </p:nvGrpSpPr>
        <p:grpSpPr>
          <a:xfrm>
            <a:off x="1511449" y="2800079"/>
            <a:ext cx="1484975" cy="1421009"/>
            <a:chOff x="2460194" y="1378081"/>
            <a:chExt cx="1767828" cy="1691677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645" t="5926" r="41244" b="66666"/>
            <a:stretch/>
          </p:blipFill>
          <p:spPr bwMode="auto">
            <a:xfrm>
              <a:off x="2460194" y="1378081"/>
              <a:ext cx="1767828" cy="16916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Rectangle 1"/>
            <p:cNvSpPr/>
            <p:nvPr/>
          </p:nvSpPr>
          <p:spPr>
            <a:xfrm>
              <a:off x="3469481" y="1893093"/>
              <a:ext cx="585787" cy="15954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200"/>
            </a:p>
          </p:txBody>
        </p:sp>
      </p:grpSp>
      <p:grpSp>
        <p:nvGrpSpPr>
          <p:cNvPr id="9" name="Groupe 8"/>
          <p:cNvGrpSpPr>
            <a:grpSpLocks noChangeAspect="1"/>
          </p:cNvGrpSpPr>
          <p:nvPr/>
        </p:nvGrpSpPr>
        <p:grpSpPr>
          <a:xfrm>
            <a:off x="5367796" y="2773961"/>
            <a:ext cx="1484975" cy="1426452"/>
            <a:chOff x="6068892" y="1340769"/>
            <a:chExt cx="1767828" cy="1698157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645" t="50830" r="41244" b="21657"/>
            <a:stretch/>
          </p:blipFill>
          <p:spPr bwMode="auto">
            <a:xfrm>
              <a:off x="6068892" y="1340769"/>
              <a:ext cx="1767828" cy="16981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7" name="Rectangle 36"/>
            <p:cNvSpPr/>
            <p:nvPr/>
          </p:nvSpPr>
          <p:spPr>
            <a:xfrm>
              <a:off x="6993732" y="1885948"/>
              <a:ext cx="661194" cy="1976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200"/>
            </a:p>
          </p:txBody>
        </p:sp>
      </p:grpSp>
      <p:sp>
        <p:nvSpPr>
          <p:cNvPr id="10" name="ZoneTexte 9"/>
          <p:cNvSpPr txBox="1"/>
          <p:nvPr/>
        </p:nvSpPr>
        <p:spPr>
          <a:xfrm>
            <a:off x="5809842" y="4221088"/>
            <a:ext cx="6048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CD19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1892174" y="4221088"/>
            <a:ext cx="6048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CD19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 rot="16200000">
            <a:off x="4866536" y="3291487"/>
            <a:ext cx="6048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PKH67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 rot="16200000">
            <a:off x="1012149" y="3287640"/>
            <a:ext cx="6048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PKH67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1296008" y="2276873"/>
            <a:ext cx="17971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Trogocytosis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living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acceptor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cells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0" y="0"/>
            <a:ext cx="25178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cap="small" dirty="0" err="1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fr-FR" sz="1200" b="1" cap="small" dirty="0" smtClean="0">
                <a:latin typeface="Times New Roman" pitchFamily="18" charset="0"/>
                <a:cs typeface="Times New Roman" pitchFamily="18" charset="0"/>
              </a:rPr>
              <a:t> Figure 3</a:t>
            </a:r>
            <a:endParaRPr lang="fr-FR" sz="1200" b="1" cap="small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5132271" y="2276872"/>
            <a:ext cx="18159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Trogocytosis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fixed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acceptor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cells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2" name="Groupe 21"/>
          <p:cNvGrpSpPr/>
          <p:nvPr/>
        </p:nvGrpSpPr>
        <p:grpSpPr>
          <a:xfrm>
            <a:off x="1441541" y="2800079"/>
            <a:ext cx="1512168" cy="1421009"/>
            <a:chOff x="2771800" y="1215903"/>
            <a:chExt cx="1512168" cy="1421009"/>
          </a:xfrm>
        </p:grpSpPr>
        <p:cxnSp>
          <p:nvCxnSpPr>
            <p:cNvPr id="18" name="Connecteur droit avec flèche 17"/>
            <p:cNvCxnSpPr/>
            <p:nvPr/>
          </p:nvCxnSpPr>
          <p:spPr>
            <a:xfrm>
              <a:off x="2771800" y="2636912"/>
              <a:ext cx="151216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cteur droit avec flèche 41"/>
            <p:cNvCxnSpPr/>
            <p:nvPr/>
          </p:nvCxnSpPr>
          <p:spPr>
            <a:xfrm flipV="1">
              <a:off x="2771800" y="1215903"/>
              <a:ext cx="0" cy="142100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Groupe 48"/>
          <p:cNvGrpSpPr/>
          <p:nvPr/>
        </p:nvGrpSpPr>
        <p:grpSpPr>
          <a:xfrm>
            <a:off x="5292080" y="2800079"/>
            <a:ext cx="1512168" cy="1421009"/>
            <a:chOff x="2771800" y="1215903"/>
            <a:chExt cx="1512168" cy="1421009"/>
          </a:xfrm>
        </p:grpSpPr>
        <p:cxnSp>
          <p:nvCxnSpPr>
            <p:cNvPr id="50" name="Connecteur droit avec flèche 49"/>
            <p:cNvCxnSpPr/>
            <p:nvPr/>
          </p:nvCxnSpPr>
          <p:spPr>
            <a:xfrm>
              <a:off x="2771800" y="2636912"/>
              <a:ext cx="151216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cteur droit avec flèche 50"/>
            <p:cNvCxnSpPr/>
            <p:nvPr/>
          </p:nvCxnSpPr>
          <p:spPr>
            <a:xfrm flipV="1">
              <a:off x="2771800" y="1215903"/>
              <a:ext cx="0" cy="142100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Rectangle 5"/>
          <p:cNvSpPr/>
          <p:nvPr/>
        </p:nvSpPr>
        <p:spPr>
          <a:xfrm>
            <a:off x="1684060" y="2840037"/>
            <a:ext cx="1192808" cy="39265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2" name="Rectangle 51"/>
          <p:cNvSpPr/>
          <p:nvPr/>
        </p:nvSpPr>
        <p:spPr>
          <a:xfrm>
            <a:off x="5532145" y="2840037"/>
            <a:ext cx="1192808" cy="39265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ZoneTexte 7"/>
          <p:cNvSpPr txBox="1"/>
          <p:nvPr/>
        </p:nvSpPr>
        <p:spPr>
          <a:xfrm>
            <a:off x="3402462" y="2843640"/>
            <a:ext cx="1234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Donor</a:t>
            </a:r>
            <a:r>
              <a:rPr lang="fr-FR" dirty="0" smtClean="0"/>
              <a:t> </a:t>
            </a:r>
            <a:r>
              <a:rPr lang="fr-FR" dirty="0" err="1" smtClean="0"/>
              <a:t>cells</a:t>
            </a:r>
            <a:endParaRPr lang="fr-FR" dirty="0"/>
          </a:p>
        </p:txBody>
      </p:sp>
      <p:sp>
        <p:nvSpPr>
          <p:cNvPr id="53" name="ZoneTexte 52"/>
          <p:cNvSpPr txBox="1"/>
          <p:nvPr/>
        </p:nvSpPr>
        <p:spPr>
          <a:xfrm>
            <a:off x="3275856" y="3414597"/>
            <a:ext cx="14878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Acceptor</a:t>
            </a:r>
            <a:r>
              <a:rPr lang="fr-FR" dirty="0" smtClean="0"/>
              <a:t> </a:t>
            </a:r>
            <a:r>
              <a:rPr lang="fr-FR" dirty="0" err="1" smtClean="0"/>
              <a:t>cells</a:t>
            </a:r>
            <a:endParaRPr lang="fr-FR" dirty="0"/>
          </a:p>
        </p:txBody>
      </p:sp>
      <p:sp>
        <p:nvSpPr>
          <p:cNvPr id="13" name="Parenthèse fermante 12"/>
          <p:cNvSpPr/>
          <p:nvPr/>
        </p:nvSpPr>
        <p:spPr>
          <a:xfrm>
            <a:off x="2996424" y="2840037"/>
            <a:ext cx="45719" cy="372935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" name="Parenthèse fermante 54"/>
          <p:cNvSpPr/>
          <p:nvPr/>
        </p:nvSpPr>
        <p:spPr>
          <a:xfrm>
            <a:off x="2995444" y="3272089"/>
            <a:ext cx="45719" cy="732975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Parenthèse ouvrante 19"/>
          <p:cNvSpPr/>
          <p:nvPr/>
        </p:nvSpPr>
        <p:spPr>
          <a:xfrm>
            <a:off x="4932323" y="2840037"/>
            <a:ext cx="45719" cy="37293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6" name="Parenthèse ouvrante 55"/>
          <p:cNvSpPr/>
          <p:nvPr/>
        </p:nvSpPr>
        <p:spPr>
          <a:xfrm>
            <a:off x="4932040" y="3272089"/>
            <a:ext cx="45719" cy="73297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747259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21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ommissariat à l'Energie Atomiqu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UMARTIN Julien</dc:creator>
  <cp:lastModifiedBy>LE MAOULT  joël 202104</cp:lastModifiedBy>
  <cp:revision>50</cp:revision>
  <dcterms:created xsi:type="dcterms:W3CDTF">2012-10-16T10:09:19Z</dcterms:created>
  <dcterms:modified xsi:type="dcterms:W3CDTF">2014-06-23T14:11:37Z</dcterms:modified>
</cp:coreProperties>
</file>